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11"/>
  </p:notesMasterIdLst>
  <p:sldIdLst>
    <p:sldId id="305" r:id="rId2"/>
    <p:sldId id="279" r:id="rId3"/>
    <p:sldId id="311" r:id="rId4"/>
    <p:sldId id="315" r:id="rId5"/>
    <p:sldId id="317" r:id="rId6"/>
    <p:sldId id="319" r:id="rId7"/>
    <p:sldId id="262" r:id="rId8"/>
    <p:sldId id="261" r:id="rId9"/>
    <p:sldId id="318" r:id="rId10"/>
  </p:sldIdLst>
  <p:sldSz cx="12192000" cy="6858000"/>
  <p:notesSz cx="6858000" cy="9144000"/>
  <p:defaultTextStyle>
    <a:defPPr>
      <a:defRPr lang="fr-T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A5B0E82-8435-AE7C-3ED5-DCB1CA1D331C}" name="Nabil E. Miled" initials="NM" userId="S::04220780@uj.edu.sa::4d8398db-fd6a-4e95-b1e8-2c97fb8d8f4c" providerId="AD"/>
  <p188:author id="{1EC698D1-CC99-2008-B2E3-ADA4D25DECCD}" name="Chantal Ebel" initials="CE" userId="S::chantal.ebel@digital-innovation-partner.ch::33ff01e4-6b05-434f-bd56-92b7118bb821" providerId="AD"/>
  <p188:author id="{D5143AD7-E749-5E1E-371D-A585C0C727CD}" name="User" initials="U" userId="User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D2E94A5-6401-42AA-86FC-CA03E37AF5B8}" v="5" dt="2025-03-05T14:56:46.93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779" autoAdjust="0"/>
    <p:restoredTop sz="94660"/>
  </p:normalViewPr>
  <p:slideViewPr>
    <p:cSldViewPr snapToGrid="0" showGuides="1">
      <p:cViewPr varScale="1">
        <p:scale>
          <a:sx n="70" d="100"/>
          <a:sy n="70" d="100"/>
        </p:scale>
        <p:origin x="544" y="5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18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17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antal Ebel" userId="33ff01e4-6b05-434f-bd56-92b7118bb821" providerId="ADAL" clId="{2D2E94A5-6401-42AA-86FC-CA03E37AF5B8}"/>
    <pc:docChg chg="undo redo custSel addSld delSld modSld">
      <pc:chgData name="Chantal Ebel" userId="33ff01e4-6b05-434f-bd56-92b7118bb821" providerId="ADAL" clId="{2D2E94A5-6401-42AA-86FC-CA03E37AF5B8}" dt="2025-03-05T14:57:16.020" v="119" actId="1076"/>
      <pc:docMkLst>
        <pc:docMk/>
      </pc:docMkLst>
      <pc:sldChg chg="add">
        <pc:chgData name="Chantal Ebel" userId="33ff01e4-6b05-434f-bd56-92b7118bb821" providerId="ADAL" clId="{2D2E94A5-6401-42AA-86FC-CA03E37AF5B8}" dt="2025-03-05T14:56:34.939" v="74"/>
        <pc:sldMkLst>
          <pc:docMk/>
          <pc:sldMk cId="0" sldId="261"/>
        </pc:sldMkLst>
      </pc:sldChg>
      <pc:sldChg chg="add">
        <pc:chgData name="Chantal Ebel" userId="33ff01e4-6b05-434f-bd56-92b7118bb821" providerId="ADAL" clId="{2D2E94A5-6401-42AA-86FC-CA03E37AF5B8}" dt="2025-03-05T14:56:34.939" v="74"/>
        <pc:sldMkLst>
          <pc:docMk/>
          <pc:sldMk cId="0" sldId="262"/>
        </pc:sldMkLst>
      </pc:sldChg>
      <pc:sldChg chg="modSp mod">
        <pc:chgData name="Chantal Ebel" userId="33ff01e4-6b05-434f-bd56-92b7118bb821" providerId="ADAL" clId="{2D2E94A5-6401-42AA-86FC-CA03E37AF5B8}" dt="2025-02-18T10:36:50.250" v="70" actId="114"/>
        <pc:sldMkLst>
          <pc:docMk/>
          <pc:sldMk cId="350297667" sldId="279"/>
        </pc:sldMkLst>
        <pc:spChg chg="mod">
          <ac:chgData name="Chantal Ebel" userId="33ff01e4-6b05-434f-bd56-92b7118bb821" providerId="ADAL" clId="{2D2E94A5-6401-42AA-86FC-CA03E37AF5B8}" dt="2025-02-18T10:36:50.250" v="70" actId="114"/>
          <ac:spMkLst>
            <pc:docMk/>
            <pc:sldMk cId="350297667" sldId="279"/>
            <ac:spMk id="34" creationId="{06602378-9EF7-4F08-B33C-00146388255D}"/>
          </ac:spMkLst>
        </pc:spChg>
      </pc:sldChg>
      <pc:sldChg chg="addSp delSp modSp mod">
        <pc:chgData name="Chantal Ebel" userId="33ff01e4-6b05-434f-bd56-92b7118bb821" providerId="ADAL" clId="{2D2E94A5-6401-42AA-86FC-CA03E37AF5B8}" dt="2025-02-18T10:35:38.701" v="58" actId="14100"/>
        <pc:sldMkLst>
          <pc:docMk/>
          <pc:sldMk cId="3833220591" sldId="305"/>
        </pc:sldMkLst>
        <pc:spChg chg="mod">
          <ac:chgData name="Chantal Ebel" userId="33ff01e4-6b05-434f-bd56-92b7118bb821" providerId="ADAL" clId="{2D2E94A5-6401-42AA-86FC-CA03E37AF5B8}" dt="2025-02-18T10:32:49.043" v="45" actId="114"/>
          <ac:spMkLst>
            <pc:docMk/>
            <pc:sldMk cId="3833220591" sldId="305"/>
            <ac:spMk id="3" creationId="{252531BA-EB91-6F55-4231-11C7D9B5572A}"/>
          </ac:spMkLst>
        </pc:spChg>
        <pc:spChg chg="ord">
          <ac:chgData name="Chantal Ebel" userId="33ff01e4-6b05-434f-bd56-92b7118bb821" providerId="ADAL" clId="{2D2E94A5-6401-42AA-86FC-CA03E37AF5B8}" dt="2025-02-18T10:35:05.732" v="55" actId="166"/>
          <ac:spMkLst>
            <pc:docMk/>
            <pc:sldMk cId="3833220591" sldId="305"/>
            <ac:spMk id="4" creationId="{94081BF0-96C0-3407-9DDA-F0D7D583CCEE}"/>
          </ac:spMkLst>
        </pc:spChg>
        <pc:spChg chg="ord">
          <ac:chgData name="Chantal Ebel" userId="33ff01e4-6b05-434f-bd56-92b7118bb821" providerId="ADAL" clId="{2D2E94A5-6401-42AA-86FC-CA03E37AF5B8}" dt="2025-02-18T10:35:05.732" v="55" actId="166"/>
          <ac:spMkLst>
            <pc:docMk/>
            <pc:sldMk cId="3833220591" sldId="305"/>
            <ac:spMk id="5" creationId="{0CC0F97E-030C-D196-752A-3A4FD2E75ED7}"/>
          </ac:spMkLst>
        </pc:spChg>
        <pc:spChg chg="mod">
          <ac:chgData name="Chantal Ebel" userId="33ff01e4-6b05-434f-bd56-92b7118bb821" providerId="ADAL" clId="{2D2E94A5-6401-42AA-86FC-CA03E37AF5B8}" dt="2025-02-18T10:35:38.701" v="58" actId="14100"/>
          <ac:spMkLst>
            <pc:docMk/>
            <pc:sldMk cId="3833220591" sldId="305"/>
            <ac:spMk id="6" creationId="{109A6365-7D5C-1730-5D56-E666B0713DEB}"/>
          </ac:spMkLst>
        </pc:spChg>
        <pc:spChg chg="mod">
          <ac:chgData name="Chantal Ebel" userId="33ff01e4-6b05-434f-bd56-92b7118bb821" providerId="ADAL" clId="{2D2E94A5-6401-42AA-86FC-CA03E37AF5B8}" dt="2025-02-18T10:32:53.882" v="46" actId="114"/>
          <ac:spMkLst>
            <pc:docMk/>
            <pc:sldMk cId="3833220591" sldId="305"/>
            <ac:spMk id="12" creationId="{EB84E6A1-B3C5-BD5E-B846-BF8B4EE620E0}"/>
          </ac:spMkLst>
        </pc:spChg>
        <pc:spChg chg="mod">
          <ac:chgData name="Chantal Ebel" userId="33ff01e4-6b05-434f-bd56-92b7118bb821" providerId="ADAL" clId="{2D2E94A5-6401-42AA-86FC-CA03E37AF5B8}" dt="2025-02-18T10:33:08.754" v="50" actId="114"/>
          <ac:spMkLst>
            <pc:docMk/>
            <pc:sldMk cId="3833220591" sldId="305"/>
            <ac:spMk id="13" creationId="{3D16639F-1E41-B12A-199E-B34CA20A7C52}"/>
          </ac:spMkLst>
        </pc:spChg>
        <pc:spChg chg="ord">
          <ac:chgData name="Chantal Ebel" userId="33ff01e4-6b05-434f-bd56-92b7118bb821" providerId="ADAL" clId="{2D2E94A5-6401-42AA-86FC-CA03E37AF5B8}" dt="2025-02-18T10:35:05.732" v="55" actId="166"/>
          <ac:spMkLst>
            <pc:docMk/>
            <pc:sldMk cId="3833220591" sldId="305"/>
            <ac:spMk id="28" creationId="{B2166478-08C7-0CB9-5A75-627ABB12789A}"/>
          </ac:spMkLst>
        </pc:spChg>
        <pc:spChg chg="ord">
          <ac:chgData name="Chantal Ebel" userId="33ff01e4-6b05-434f-bd56-92b7118bb821" providerId="ADAL" clId="{2D2E94A5-6401-42AA-86FC-CA03E37AF5B8}" dt="2025-02-18T10:35:05.732" v="55" actId="166"/>
          <ac:spMkLst>
            <pc:docMk/>
            <pc:sldMk cId="3833220591" sldId="305"/>
            <ac:spMk id="29" creationId="{098FC30F-D9FA-C174-DC50-EB69C86773B8}"/>
          </ac:spMkLst>
        </pc:spChg>
        <pc:spChg chg="ord">
          <ac:chgData name="Chantal Ebel" userId="33ff01e4-6b05-434f-bd56-92b7118bb821" providerId="ADAL" clId="{2D2E94A5-6401-42AA-86FC-CA03E37AF5B8}" dt="2025-02-18T10:35:05.732" v="55" actId="166"/>
          <ac:spMkLst>
            <pc:docMk/>
            <pc:sldMk cId="3833220591" sldId="305"/>
            <ac:spMk id="32" creationId="{FB413EF6-B7F4-488A-D403-959A28064B04}"/>
          </ac:spMkLst>
        </pc:spChg>
        <pc:picChg chg="add mod">
          <ac:chgData name="Chantal Ebel" userId="33ff01e4-6b05-434f-bd56-92b7118bb821" providerId="ADAL" clId="{2D2E94A5-6401-42AA-86FC-CA03E37AF5B8}" dt="2025-02-18T10:32:25.592" v="40" actId="1076"/>
          <ac:picMkLst>
            <pc:docMk/>
            <pc:sldMk cId="3833220591" sldId="305"/>
            <ac:picMk id="7" creationId="{60B9439A-FBB7-4F83-314E-1FC2D7EEB6E1}"/>
          </ac:picMkLst>
        </pc:picChg>
        <pc:picChg chg="add mod">
          <ac:chgData name="Chantal Ebel" userId="33ff01e4-6b05-434f-bd56-92b7118bb821" providerId="ADAL" clId="{2D2E94A5-6401-42AA-86FC-CA03E37AF5B8}" dt="2025-02-18T10:32:18.232" v="39" actId="1076"/>
          <ac:picMkLst>
            <pc:docMk/>
            <pc:sldMk cId="3833220591" sldId="305"/>
            <ac:picMk id="8" creationId="{85A36625-2C08-B19E-63FC-E2E830BB27B8}"/>
          </ac:picMkLst>
        </pc:picChg>
      </pc:sldChg>
      <pc:sldChg chg="modSp mod">
        <pc:chgData name="Chantal Ebel" userId="33ff01e4-6b05-434f-bd56-92b7118bb821" providerId="ADAL" clId="{2D2E94A5-6401-42AA-86FC-CA03E37AF5B8}" dt="2025-02-18T10:37:13.911" v="72" actId="114"/>
        <pc:sldMkLst>
          <pc:docMk/>
          <pc:sldMk cId="2526496346" sldId="317"/>
        </pc:sldMkLst>
        <pc:spChg chg="mod">
          <ac:chgData name="Chantal Ebel" userId="33ff01e4-6b05-434f-bd56-92b7118bb821" providerId="ADAL" clId="{2D2E94A5-6401-42AA-86FC-CA03E37AF5B8}" dt="2025-02-18T10:37:13.911" v="72" actId="114"/>
          <ac:spMkLst>
            <pc:docMk/>
            <pc:sldMk cId="2526496346" sldId="317"/>
            <ac:spMk id="8" creationId="{5E2C66FF-2E33-0FB3-23F2-FD9230C12F29}"/>
          </ac:spMkLst>
        </pc:spChg>
      </pc:sldChg>
      <pc:sldChg chg="new">
        <pc:chgData name="Chantal Ebel" userId="33ff01e4-6b05-434f-bd56-92b7118bb821" providerId="ADAL" clId="{2D2E94A5-6401-42AA-86FC-CA03E37AF5B8}" dt="2025-03-05T14:55:54.939" v="73" actId="680"/>
        <pc:sldMkLst>
          <pc:docMk/>
          <pc:sldMk cId="175064367" sldId="318"/>
        </pc:sldMkLst>
      </pc:sldChg>
      <pc:sldChg chg="addSp delSp modSp new add del mod">
        <pc:chgData name="Chantal Ebel" userId="33ff01e4-6b05-434f-bd56-92b7118bb821" providerId="ADAL" clId="{2D2E94A5-6401-42AA-86FC-CA03E37AF5B8}" dt="2025-02-18T10:36:19.489" v="63" actId="47"/>
        <pc:sldMkLst>
          <pc:docMk/>
          <pc:sldMk cId="3243864160" sldId="318"/>
        </pc:sldMkLst>
      </pc:sldChg>
      <pc:sldChg chg="addSp modSp new mod">
        <pc:chgData name="Chantal Ebel" userId="33ff01e4-6b05-434f-bd56-92b7118bb821" providerId="ADAL" clId="{2D2E94A5-6401-42AA-86FC-CA03E37AF5B8}" dt="2025-03-05T14:57:16.020" v="119" actId="1076"/>
        <pc:sldMkLst>
          <pc:docMk/>
          <pc:sldMk cId="287897114" sldId="319"/>
        </pc:sldMkLst>
        <pc:spChg chg="add mod">
          <ac:chgData name="Chantal Ebel" userId="33ff01e4-6b05-434f-bd56-92b7118bb821" providerId="ADAL" clId="{2D2E94A5-6401-42AA-86FC-CA03E37AF5B8}" dt="2025-03-05T14:57:16.020" v="119" actId="1076"/>
          <ac:spMkLst>
            <pc:docMk/>
            <pc:sldMk cId="287897114" sldId="319"/>
            <ac:spMk id="2" creationId="{5A30A076-42D2-D72E-FF8A-00A31F511182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F35BB85-2992-453A-BFAA-A1AED2F2D877}" type="datetimeFigureOut">
              <a:rPr lang="fr-FR" smtClean="0"/>
              <a:t>05/03/202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A1B9B38-D755-42B0-9BCF-C096DCDCDE4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60447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fr-FR" dirty="0" err="1"/>
              <a:t>Anti-HA</a:t>
            </a:r>
            <a:r>
              <a:rPr lang="fr-FR" dirty="0"/>
              <a:t> </a:t>
            </a:r>
            <a:r>
              <a:rPr lang="fr-FR" dirty="0" err="1"/>
              <a:t>after</a:t>
            </a:r>
            <a:r>
              <a:rPr lang="fr-FR" dirty="0"/>
              <a:t> 852.8 sec</a:t>
            </a: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945898-99D8-4F7A-8341-0F8015DF40CA}" type="slidenum">
              <a:rPr lang="fr-FR" smtClean="0"/>
              <a:pPr/>
              <a:t>8</a:t>
            </a:fld>
            <a:endParaRPr lang="fr-FR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768C57F-59F7-D544-5C35-18673D1DB89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fr-TN"/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8FD3DC40-451B-1DA5-FFE5-0A212BF268B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fr-TN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DA64A06-1480-6490-5ADE-C9D4D07858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4DC39-DBC7-4F40-8E4C-2B7CD5DB993F}" type="datetimeFigureOut">
              <a:rPr lang="fr-TN" smtClean="0"/>
              <a:t>03/05/2025</a:t>
            </a:fld>
            <a:endParaRPr lang="fr-TN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331896F-DC91-4264-6E79-937CA0E7D0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TN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6CC37CF-C727-6B66-6EB5-CC6DFA347C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B5549-F618-4996-B707-396A03E3A149}" type="slidenum">
              <a:rPr lang="fr-TN" smtClean="0"/>
              <a:t>‹N°›</a:t>
            </a:fld>
            <a:endParaRPr lang="fr-TN"/>
          </a:p>
        </p:txBody>
      </p:sp>
    </p:spTree>
    <p:extLst>
      <p:ext uri="{BB962C8B-B14F-4D97-AF65-F5344CB8AC3E}">
        <p14:creationId xmlns:p14="http://schemas.microsoft.com/office/powerpoint/2010/main" val="1678881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592FB76-938F-2CAB-7AEC-2BE7A14D3B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TN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99CDFFBD-C8C8-4F54-75B1-7924F73E09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TN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3130F02-514F-A7B8-D6F3-922E87D939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4DC39-DBC7-4F40-8E4C-2B7CD5DB993F}" type="datetimeFigureOut">
              <a:rPr lang="fr-TN" smtClean="0"/>
              <a:t>03/05/2025</a:t>
            </a:fld>
            <a:endParaRPr lang="fr-TN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C9C5D90-0B54-F41D-F21D-2ECF140C89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TN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410A6CE-4CBF-9DD2-D684-53A1EC97FB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B5549-F618-4996-B707-396A03E3A149}" type="slidenum">
              <a:rPr lang="fr-TN" smtClean="0"/>
              <a:t>‹N°›</a:t>
            </a:fld>
            <a:endParaRPr lang="fr-TN"/>
          </a:p>
        </p:txBody>
      </p:sp>
    </p:spTree>
    <p:extLst>
      <p:ext uri="{BB962C8B-B14F-4D97-AF65-F5344CB8AC3E}">
        <p14:creationId xmlns:p14="http://schemas.microsoft.com/office/powerpoint/2010/main" val="15362868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24194EEA-19FD-3DCC-3735-3F1EBEB4F30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fr-TN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C59B0A62-95AF-1112-6B60-FCF89D9FBB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TN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8D01FB6-CCB0-6D5E-9D8D-87325BD19A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4DC39-DBC7-4F40-8E4C-2B7CD5DB993F}" type="datetimeFigureOut">
              <a:rPr lang="fr-TN" smtClean="0"/>
              <a:t>03/05/2025</a:t>
            </a:fld>
            <a:endParaRPr lang="fr-TN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9B2BCFF-1D20-9533-BB8F-74DAC7EC8B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TN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3CBD6CA-23AB-6859-A6A8-0E80601BC8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B5549-F618-4996-B707-396A03E3A149}" type="slidenum">
              <a:rPr lang="fr-TN" smtClean="0"/>
              <a:t>‹N°›</a:t>
            </a:fld>
            <a:endParaRPr lang="fr-TN"/>
          </a:p>
        </p:txBody>
      </p:sp>
    </p:spTree>
    <p:extLst>
      <p:ext uri="{BB962C8B-B14F-4D97-AF65-F5344CB8AC3E}">
        <p14:creationId xmlns:p14="http://schemas.microsoft.com/office/powerpoint/2010/main" val="18883116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58025A0-6CC5-B61C-1007-70017E38B1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TN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CEB1FC20-DBE8-D7A8-A6F2-6C6934B2C74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TN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7D138BA-C9EB-37EB-E4B4-4A74812287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4DC39-DBC7-4F40-8E4C-2B7CD5DB993F}" type="datetimeFigureOut">
              <a:rPr lang="fr-TN" smtClean="0"/>
              <a:t>03/05/2025</a:t>
            </a:fld>
            <a:endParaRPr lang="fr-TN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8DF52ED-D3DB-7308-3F32-57B2B4A21F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TN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5E64C53-9BED-2704-9814-0DAFB31970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B5549-F618-4996-B707-396A03E3A149}" type="slidenum">
              <a:rPr lang="fr-TN" smtClean="0"/>
              <a:t>‹N°›</a:t>
            </a:fld>
            <a:endParaRPr lang="fr-TN"/>
          </a:p>
        </p:txBody>
      </p:sp>
    </p:spTree>
    <p:extLst>
      <p:ext uri="{BB962C8B-B14F-4D97-AF65-F5344CB8AC3E}">
        <p14:creationId xmlns:p14="http://schemas.microsoft.com/office/powerpoint/2010/main" val="5576260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9D81B65-4EDD-9089-5CEF-E13AD4E4F5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fr-TN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2ED8AB2-6679-5AE5-CAC9-89811071EC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A594EB2-5689-B2F3-58CF-3D4AC5FE35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4DC39-DBC7-4F40-8E4C-2B7CD5DB993F}" type="datetimeFigureOut">
              <a:rPr lang="fr-TN" smtClean="0"/>
              <a:t>03/05/2025</a:t>
            </a:fld>
            <a:endParaRPr lang="fr-TN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F1BB12C-7C02-8429-CDCB-8820FA4490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TN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56A51F9-4CCE-602F-FDD8-E9010ABAE1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B5549-F618-4996-B707-396A03E3A149}" type="slidenum">
              <a:rPr lang="fr-TN" smtClean="0"/>
              <a:t>‹N°›</a:t>
            </a:fld>
            <a:endParaRPr lang="fr-TN"/>
          </a:p>
        </p:txBody>
      </p:sp>
    </p:spTree>
    <p:extLst>
      <p:ext uri="{BB962C8B-B14F-4D97-AF65-F5344CB8AC3E}">
        <p14:creationId xmlns:p14="http://schemas.microsoft.com/office/powerpoint/2010/main" val="38074499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BAED48E-C01C-5F4B-049C-85BB449173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TN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661EB98-96A8-514A-44FC-7DB937B7DC1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TN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A27AEA63-80E9-E3F9-98C0-0B02DEDB79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TN"/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5F825E6-C5CE-F22B-2D18-960B49EC06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4DC39-DBC7-4F40-8E4C-2B7CD5DB993F}" type="datetimeFigureOut">
              <a:rPr lang="fr-TN" smtClean="0"/>
              <a:t>03/05/2025</a:t>
            </a:fld>
            <a:endParaRPr lang="fr-TN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6EB2EC53-DAB6-38F7-FDED-EDEFF430AD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TN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5B68F70-9993-E877-20DC-953270B7E6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B5549-F618-4996-B707-396A03E3A149}" type="slidenum">
              <a:rPr lang="fr-TN" smtClean="0"/>
              <a:t>‹N°›</a:t>
            </a:fld>
            <a:endParaRPr lang="fr-TN"/>
          </a:p>
        </p:txBody>
      </p:sp>
    </p:spTree>
    <p:extLst>
      <p:ext uri="{BB962C8B-B14F-4D97-AF65-F5344CB8AC3E}">
        <p14:creationId xmlns:p14="http://schemas.microsoft.com/office/powerpoint/2010/main" val="18082120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62FD4CB-404A-938D-1638-C5CEAEA438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fr-TN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BFDA36C2-E1F3-4D5B-2652-1C17D2D8C9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147C0C6-086D-961D-133D-A050F96F9B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TN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BD1EA2EE-B6FF-76C5-3D95-65919675085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76E943DB-50C4-D256-6C15-C1372467CC8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TN"/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4B9D790B-C122-1A45-D9F2-152E8060F2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4DC39-DBC7-4F40-8E4C-2B7CD5DB993F}" type="datetimeFigureOut">
              <a:rPr lang="fr-TN" smtClean="0"/>
              <a:t>03/05/2025</a:t>
            </a:fld>
            <a:endParaRPr lang="fr-TN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7CD1D0C9-3B94-046B-2241-5E38513FC9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TN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04D5AA56-00DA-8DA9-6706-C2A9EFAD89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B5549-F618-4996-B707-396A03E3A149}" type="slidenum">
              <a:rPr lang="fr-TN" smtClean="0"/>
              <a:t>‹N°›</a:t>
            </a:fld>
            <a:endParaRPr lang="fr-TN"/>
          </a:p>
        </p:txBody>
      </p:sp>
    </p:spTree>
    <p:extLst>
      <p:ext uri="{BB962C8B-B14F-4D97-AF65-F5344CB8AC3E}">
        <p14:creationId xmlns:p14="http://schemas.microsoft.com/office/powerpoint/2010/main" val="34709434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AC3CBD5-8BAF-C659-EC12-13DC78D06E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TN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C4F7B80F-0529-504A-C450-CDDDAF12E5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4DC39-DBC7-4F40-8E4C-2B7CD5DB993F}" type="datetimeFigureOut">
              <a:rPr lang="fr-TN" smtClean="0"/>
              <a:t>03/05/2025</a:t>
            </a:fld>
            <a:endParaRPr lang="fr-TN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B739C673-BBAE-BD7B-42F0-1401B3E08E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TN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014371D4-0450-C97F-6B65-E5B1AC9569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B5549-F618-4996-B707-396A03E3A149}" type="slidenum">
              <a:rPr lang="fr-TN" smtClean="0"/>
              <a:t>‹N°›</a:t>
            </a:fld>
            <a:endParaRPr lang="fr-TN"/>
          </a:p>
        </p:txBody>
      </p:sp>
    </p:spTree>
    <p:extLst>
      <p:ext uri="{BB962C8B-B14F-4D97-AF65-F5344CB8AC3E}">
        <p14:creationId xmlns:p14="http://schemas.microsoft.com/office/powerpoint/2010/main" val="28313794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97AD36D4-BB2C-283E-5BC0-F7821A18FF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4DC39-DBC7-4F40-8E4C-2B7CD5DB993F}" type="datetimeFigureOut">
              <a:rPr lang="fr-TN" smtClean="0"/>
              <a:t>03/05/2025</a:t>
            </a:fld>
            <a:endParaRPr lang="fr-TN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C45E6608-4C5E-6AB8-F12F-A092E5A16A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TN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6C1D2867-B4A1-9CDE-14DE-84CF590F05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B5549-F618-4996-B707-396A03E3A149}" type="slidenum">
              <a:rPr lang="fr-TN" smtClean="0"/>
              <a:t>‹N°›</a:t>
            </a:fld>
            <a:endParaRPr lang="fr-TN"/>
          </a:p>
        </p:txBody>
      </p:sp>
    </p:spTree>
    <p:extLst>
      <p:ext uri="{BB962C8B-B14F-4D97-AF65-F5344CB8AC3E}">
        <p14:creationId xmlns:p14="http://schemas.microsoft.com/office/powerpoint/2010/main" val="1438818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34DE63A-CC54-793F-7A03-44E3972137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fr-TN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5D93C28-8DD0-AA17-8667-D0A1D0FDEE9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TN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7FBF08AB-F7B5-025B-E830-38775C0A4E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378B6AA-23B1-B415-02F4-15BB1020EF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4DC39-DBC7-4F40-8E4C-2B7CD5DB993F}" type="datetimeFigureOut">
              <a:rPr lang="fr-TN" smtClean="0"/>
              <a:t>03/05/2025</a:t>
            </a:fld>
            <a:endParaRPr lang="fr-TN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4F5ABF6-C06C-F8B3-D966-3A392612DC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TN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756E76E-2E60-4E98-5E5C-5BA48E1207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B5549-F618-4996-B707-396A03E3A149}" type="slidenum">
              <a:rPr lang="fr-TN" smtClean="0"/>
              <a:t>‹N°›</a:t>
            </a:fld>
            <a:endParaRPr lang="fr-TN"/>
          </a:p>
        </p:txBody>
      </p:sp>
    </p:spTree>
    <p:extLst>
      <p:ext uri="{BB962C8B-B14F-4D97-AF65-F5344CB8AC3E}">
        <p14:creationId xmlns:p14="http://schemas.microsoft.com/office/powerpoint/2010/main" val="40294363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1E6FCF5-D742-79DA-D76B-77C1F48CAE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fr-TN"/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92E5CE1B-486A-787A-4A90-8963E970500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TN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B1A7E18-7F06-58A1-65DA-CF3FA40645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F4C7C95-B96C-25A5-F88B-8001A64A2F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4DC39-DBC7-4F40-8E4C-2B7CD5DB993F}" type="datetimeFigureOut">
              <a:rPr lang="fr-TN" smtClean="0"/>
              <a:t>03/05/2025</a:t>
            </a:fld>
            <a:endParaRPr lang="fr-TN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E103997-8772-79C5-1237-A786867CD7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TN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8E2BA40-B1AD-D948-6BB6-C0DDF9681B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B5549-F618-4996-B707-396A03E3A149}" type="slidenum">
              <a:rPr lang="fr-TN" smtClean="0"/>
              <a:t>‹N°›</a:t>
            </a:fld>
            <a:endParaRPr lang="fr-TN"/>
          </a:p>
        </p:txBody>
      </p:sp>
    </p:spTree>
    <p:extLst>
      <p:ext uri="{BB962C8B-B14F-4D97-AF65-F5344CB8AC3E}">
        <p14:creationId xmlns:p14="http://schemas.microsoft.com/office/powerpoint/2010/main" val="41061808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982C9762-B701-4D37-0A4C-CF1A3F10B9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fr-TN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E8D30E5-8B65-062E-F818-A6B2011EB5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TN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095430C-5D9B-0FDE-B997-429235EA092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704DC39-DBC7-4F40-8E4C-2B7CD5DB993F}" type="datetimeFigureOut">
              <a:rPr lang="fr-TN" smtClean="0"/>
              <a:t>03/05/2025</a:t>
            </a:fld>
            <a:endParaRPr lang="fr-TN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A4E60DD-8944-24C0-D367-05D12A5F49B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TN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C74BBE7-D594-0495-D3C9-3F2B7F43DA7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CFB5549-F618-4996-B707-396A03E3A149}" type="slidenum">
              <a:rPr lang="fr-TN" smtClean="0"/>
              <a:t>‹N°›</a:t>
            </a:fld>
            <a:endParaRPr lang="fr-TN"/>
          </a:p>
        </p:txBody>
      </p:sp>
    </p:spTree>
    <p:extLst>
      <p:ext uri="{BB962C8B-B14F-4D97-AF65-F5344CB8AC3E}">
        <p14:creationId xmlns:p14="http://schemas.microsoft.com/office/powerpoint/2010/main" val="7498355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T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microsoft.com/office/2007/relationships/hdphoto" Target="../media/hdphoto2.wdp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6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8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>
            <a:extLst>
              <a:ext uri="{FF2B5EF4-FFF2-40B4-BE49-F238E27FC236}">
                <a16:creationId xmlns:a16="http://schemas.microsoft.com/office/drawing/2014/main" id="{252531BA-EB91-6F55-4231-11C7D9B5572A}"/>
              </a:ext>
            </a:extLst>
          </p:cNvPr>
          <p:cNvSpPr txBox="1"/>
          <p:nvPr/>
        </p:nvSpPr>
        <p:spPr>
          <a:xfrm>
            <a:off x="2300604" y="82559"/>
            <a:ext cx="39423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i="1" dirty="0"/>
              <a:t>Td</a:t>
            </a:r>
            <a:r>
              <a:rPr lang="fr-FR" sz="1600" b="1" dirty="0"/>
              <a:t>PP1-cYFP +BRI1-nYFP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648CE6AA-C931-07B6-BC4F-010189395A94}"/>
              </a:ext>
            </a:extLst>
          </p:cNvPr>
          <p:cNvSpPr txBox="1"/>
          <p:nvPr/>
        </p:nvSpPr>
        <p:spPr>
          <a:xfrm>
            <a:off x="1545933" y="5770197"/>
            <a:ext cx="12418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Fluorescence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7E6259EB-7E72-F056-E354-B04539116217}"/>
              </a:ext>
            </a:extLst>
          </p:cNvPr>
          <p:cNvSpPr txBox="1"/>
          <p:nvPr/>
        </p:nvSpPr>
        <p:spPr>
          <a:xfrm>
            <a:off x="4799161" y="5823109"/>
            <a:ext cx="3882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BF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EB84E6A1-B3C5-BD5E-B846-BF8B4EE620E0}"/>
              </a:ext>
            </a:extLst>
          </p:cNvPr>
          <p:cNvSpPr txBox="1"/>
          <p:nvPr/>
        </p:nvSpPr>
        <p:spPr>
          <a:xfrm>
            <a:off x="2300604" y="6025064"/>
            <a:ext cx="33924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/>
              <a:t>BRI1-cYFP + </a:t>
            </a:r>
            <a:r>
              <a:rPr lang="fr-FR" sz="1600" b="1" i="1" dirty="0"/>
              <a:t>Td</a:t>
            </a:r>
            <a:r>
              <a:rPr lang="fr-FR" sz="1600" b="1" dirty="0"/>
              <a:t>RL1-nYFP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3D16639F-1E41-B12A-199E-B34CA20A7C52}"/>
              </a:ext>
            </a:extLst>
          </p:cNvPr>
          <p:cNvSpPr txBox="1"/>
          <p:nvPr/>
        </p:nvSpPr>
        <p:spPr>
          <a:xfrm>
            <a:off x="7956128" y="82559"/>
            <a:ext cx="2870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/>
              <a:t>BRI1-cYFP + </a:t>
            </a:r>
            <a:r>
              <a:rPr lang="fr-FR" sz="1600" b="1" i="1" dirty="0"/>
              <a:t>At</a:t>
            </a:r>
            <a:r>
              <a:rPr lang="fr-FR" sz="1600" b="1" dirty="0"/>
              <a:t>-I2-nYFP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493A3782-77DA-F210-900A-E501CB1E3F18}"/>
              </a:ext>
            </a:extLst>
          </p:cNvPr>
          <p:cNvSpPr txBox="1"/>
          <p:nvPr/>
        </p:nvSpPr>
        <p:spPr>
          <a:xfrm>
            <a:off x="6993060" y="435949"/>
            <a:ext cx="12418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Fluorescence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0EB11379-11EA-E384-BC1C-549A02B4887C}"/>
              </a:ext>
            </a:extLst>
          </p:cNvPr>
          <p:cNvSpPr txBox="1"/>
          <p:nvPr/>
        </p:nvSpPr>
        <p:spPr>
          <a:xfrm>
            <a:off x="10352968" y="435949"/>
            <a:ext cx="3882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BF</a:t>
            </a:r>
          </a:p>
        </p:txBody>
      </p:sp>
      <p:pic>
        <p:nvPicPr>
          <p:cNvPr id="30" name="Picture 29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37342" y="702168"/>
            <a:ext cx="2533565" cy="2533565"/>
          </a:xfrm>
          <a:prstGeom prst="rect">
            <a:avLst/>
          </a:prstGeom>
        </p:spPr>
      </p:pic>
      <p:pic>
        <p:nvPicPr>
          <p:cNvPr id="31" name="Picture 30"/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28142" y="702168"/>
            <a:ext cx="2533565" cy="2533565"/>
          </a:xfrm>
          <a:prstGeom prst="rect">
            <a:avLst/>
          </a:prstGeom>
        </p:spPr>
      </p:pic>
      <p:sp>
        <p:nvSpPr>
          <p:cNvPr id="33" name="ZoneTexte 22">
            <a:extLst>
              <a:ext uri="{FF2B5EF4-FFF2-40B4-BE49-F238E27FC236}">
                <a16:creationId xmlns:a16="http://schemas.microsoft.com/office/drawing/2014/main" id="{80C96648-FE41-C3F5-535A-358E88A78E33}"/>
              </a:ext>
            </a:extLst>
          </p:cNvPr>
          <p:cNvSpPr txBox="1"/>
          <p:nvPr/>
        </p:nvSpPr>
        <p:spPr>
          <a:xfrm>
            <a:off x="8962839" y="70089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solidFill>
                  <a:schemeClr val="bg1"/>
                </a:solidFill>
              </a:rPr>
              <a:t>F</a:t>
            </a:r>
          </a:p>
        </p:txBody>
      </p:sp>
      <p:pic>
        <p:nvPicPr>
          <p:cNvPr id="34" name="Picture 33"/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3992" y="3312272"/>
            <a:ext cx="2533565" cy="2533565"/>
          </a:xfrm>
          <a:prstGeom prst="rect">
            <a:avLst/>
          </a:prstGeom>
        </p:spPr>
      </p:pic>
      <p:pic>
        <p:nvPicPr>
          <p:cNvPr id="35" name="Picture 34"/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4792" y="3312272"/>
            <a:ext cx="2533565" cy="2533565"/>
          </a:xfrm>
          <a:prstGeom prst="rect">
            <a:avLst/>
          </a:prstGeom>
        </p:spPr>
      </p:pic>
      <p:sp>
        <p:nvSpPr>
          <p:cNvPr id="36" name="ZoneTexte 19">
            <a:extLst>
              <a:ext uri="{FF2B5EF4-FFF2-40B4-BE49-F238E27FC236}">
                <a16:creationId xmlns:a16="http://schemas.microsoft.com/office/drawing/2014/main" id="{361CE301-1BEB-F7C8-180E-FB01FBA15588}"/>
              </a:ext>
            </a:extLst>
          </p:cNvPr>
          <p:cNvSpPr txBox="1"/>
          <p:nvPr/>
        </p:nvSpPr>
        <p:spPr>
          <a:xfrm>
            <a:off x="1040587" y="3320024"/>
            <a:ext cx="344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solidFill>
                  <a:schemeClr val="bg1"/>
                </a:solidFill>
              </a:rPr>
              <a:t>C</a:t>
            </a:r>
          </a:p>
        </p:txBody>
      </p:sp>
      <p:sp>
        <p:nvSpPr>
          <p:cNvPr id="37" name="ZoneTexte 20">
            <a:extLst>
              <a:ext uri="{FF2B5EF4-FFF2-40B4-BE49-F238E27FC236}">
                <a16:creationId xmlns:a16="http://schemas.microsoft.com/office/drawing/2014/main" id="{91FB27F6-D36B-39C0-1CE1-734A8769FAC0}"/>
              </a:ext>
            </a:extLst>
          </p:cNvPr>
          <p:cNvSpPr txBox="1"/>
          <p:nvPr/>
        </p:nvSpPr>
        <p:spPr>
          <a:xfrm>
            <a:off x="3614792" y="3320024"/>
            <a:ext cx="343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solidFill>
                  <a:schemeClr val="bg1"/>
                </a:solidFill>
              </a:rPr>
              <a:t>D</a:t>
            </a: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B7FF9482-9245-1C46-C11C-294D10375ED3}"/>
              </a:ext>
            </a:extLst>
          </p:cNvPr>
          <p:cNvSpPr txBox="1"/>
          <p:nvPr/>
        </p:nvSpPr>
        <p:spPr>
          <a:xfrm>
            <a:off x="11098624" y="6556248"/>
            <a:ext cx="1093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igure S1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109A6365-7D5C-1730-5D56-E666B0713DEB}"/>
              </a:ext>
            </a:extLst>
          </p:cNvPr>
          <p:cNvSpPr txBox="1"/>
          <p:nvPr/>
        </p:nvSpPr>
        <p:spPr>
          <a:xfrm>
            <a:off x="6337343" y="3622268"/>
            <a:ext cx="5614454" cy="23083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fr-FR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upplementary</a:t>
            </a:r>
            <a:r>
              <a:rPr lang="fr-FR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Figure S1</a:t>
            </a:r>
            <a:r>
              <a:rPr lang="fr-FR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: </a:t>
            </a:r>
            <a:r>
              <a:rPr lang="fr-FR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iFC</a:t>
            </a:r>
            <a:r>
              <a:rPr lang="fr-FR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fr-FR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ssays</a:t>
            </a:r>
            <a:r>
              <a:rPr lang="fr-FR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fr-FR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using</a:t>
            </a:r>
            <a:r>
              <a:rPr lang="fr-FR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fr-FR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ifferent</a:t>
            </a:r>
            <a:r>
              <a:rPr lang="fr-FR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couples of </a:t>
            </a:r>
            <a:r>
              <a:rPr lang="fr-FR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negative</a:t>
            </a:r>
            <a:r>
              <a:rPr lang="fr-FR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fr-FR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controls</a:t>
            </a:r>
            <a:r>
              <a:rPr lang="fr-FR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</a:p>
          <a:p>
            <a:pPr algn="just"/>
            <a:r>
              <a:rPr lang="fr-FR" sz="1800" dirty="0" err="1">
                <a:latin typeface="Arial" panose="020B0604020202020204" pitchFamily="34" charset="0"/>
                <a:cs typeface="Arial" panose="020B0604020202020204" pitchFamily="34" charset="0"/>
              </a:rPr>
              <a:t>Bimolecular</a:t>
            </a:r>
            <a:r>
              <a:rPr lang="fr-FR" sz="1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800" dirty="0" err="1">
                <a:latin typeface="Arial" panose="020B0604020202020204" pitchFamily="34" charset="0"/>
                <a:cs typeface="Arial" panose="020B0604020202020204" pitchFamily="34" charset="0"/>
              </a:rPr>
              <a:t>ﬂuorescence</a:t>
            </a:r>
            <a:r>
              <a:rPr lang="fr-FR" sz="1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r-FR" sz="1800" dirty="0" err="1">
                <a:latin typeface="Arial" panose="020B0604020202020204" pitchFamily="34" charset="0"/>
                <a:cs typeface="Arial" panose="020B0604020202020204" pitchFamily="34" charset="0"/>
              </a:rPr>
              <a:t>BiFC</a:t>
            </a:r>
            <a:r>
              <a:rPr lang="fr-FR" sz="18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fr-FR" sz="1800" dirty="0" err="1">
                <a:latin typeface="Arial" panose="020B0604020202020204" pitchFamily="34" charset="0"/>
                <a:cs typeface="Arial" panose="020B0604020202020204" pitchFamily="34" charset="0"/>
              </a:rPr>
              <a:t>complementation</a:t>
            </a:r>
            <a:r>
              <a:rPr lang="fr-FR" sz="1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800" dirty="0" err="1">
                <a:latin typeface="Arial" panose="020B0604020202020204" pitchFamily="34" charset="0"/>
                <a:cs typeface="Arial" panose="020B0604020202020204" pitchFamily="34" charset="0"/>
              </a:rPr>
              <a:t>assay</a:t>
            </a:r>
            <a:r>
              <a:rPr lang="fr-FR" sz="18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fr-FR" sz="1800" dirty="0" err="1">
                <a:latin typeface="Arial" panose="020B0604020202020204" pitchFamily="34" charset="0"/>
                <a:cs typeface="Arial" panose="020B0604020202020204" pitchFamily="34" charset="0"/>
              </a:rPr>
              <a:t>tobacco</a:t>
            </a:r>
            <a:r>
              <a:rPr lang="fr-FR" sz="1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800" dirty="0" err="1">
                <a:latin typeface="Arial" panose="020B0604020202020204" pitchFamily="34" charset="0"/>
                <a:cs typeface="Arial" panose="020B0604020202020204" pitchFamily="34" charset="0"/>
              </a:rPr>
              <a:t>leaf</a:t>
            </a:r>
            <a:r>
              <a:rPr lang="fr-FR" sz="1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800" dirty="0" err="1">
                <a:latin typeface="Arial" panose="020B0604020202020204" pitchFamily="34" charset="0"/>
                <a:cs typeface="Arial" panose="020B0604020202020204" pitchFamily="34" charset="0"/>
              </a:rPr>
              <a:t>after</a:t>
            </a:r>
            <a:r>
              <a:rPr lang="fr-FR" sz="1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800" dirty="0" err="1">
                <a:latin typeface="Arial" panose="020B0604020202020204" pitchFamily="34" charset="0"/>
                <a:cs typeface="Arial" panose="020B0604020202020204" pitchFamily="34" charset="0"/>
              </a:rPr>
              <a:t>co</a:t>
            </a:r>
            <a:r>
              <a:rPr lang="fr-FR" sz="1800" dirty="0">
                <a:latin typeface="Arial" panose="020B0604020202020204" pitchFamily="34" charset="0"/>
                <a:cs typeface="Arial" panose="020B0604020202020204" pitchFamily="34" charset="0"/>
              </a:rPr>
              <a:t>-Agro-infiltration of</a:t>
            </a:r>
            <a:r>
              <a:rPr lang="fr-FR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fr-FR" sz="18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</a:t>
            </a:r>
            <a:r>
              <a:rPr lang="fr-FR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P1-cYFP or BRI-</a:t>
            </a:r>
            <a:r>
              <a:rPr lang="fr-FR" sz="1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YFP</a:t>
            </a:r>
            <a:r>
              <a:rPr lang="fr-FR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fr-FR" sz="1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ith</a:t>
            </a:r>
            <a:r>
              <a:rPr lang="fr-FR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fr-FR" sz="1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ither</a:t>
            </a:r>
            <a:r>
              <a:rPr lang="fr-FR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BRI-</a:t>
            </a:r>
            <a:r>
              <a:rPr lang="fr-FR" sz="1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YFP</a:t>
            </a:r>
            <a:r>
              <a:rPr lang="fr-FR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A,B), RL1-nYFP (C,D) or AtI2-nYFP (E,F). 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Fluorescence and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bright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field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(BF) images are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shown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for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each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set of interactions. </a:t>
            </a:r>
            <a:r>
              <a:rPr lang="fr-FR" sz="1800" dirty="0" err="1">
                <a:latin typeface="Arial" panose="020B0604020202020204" pitchFamily="34" charset="0"/>
                <a:cs typeface="Arial" panose="020B0604020202020204" pitchFamily="34" charset="0"/>
              </a:rPr>
              <a:t>Scale</a:t>
            </a:r>
            <a:r>
              <a:rPr lang="fr-FR" sz="1800" dirty="0">
                <a:latin typeface="Arial" panose="020B0604020202020204" pitchFamily="34" charset="0"/>
                <a:cs typeface="Arial" panose="020B0604020202020204" pitchFamily="34" charset="0"/>
              </a:rPr>
              <a:t> bar: 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r>
              <a:rPr lang="fr-FR" sz="1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800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fr-FR" sz="18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fr-FR" dirty="0"/>
          </a:p>
        </p:txBody>
      </p:sp>
      <p:pic>
        <p:nvPicPr>
          <p:cNvPr id="7" name="Picture 57">
            <a:extLst>
              <a:ext uri="{FF2B5EF4-FFF2-40B4-BE49-F238E27FC236}">
                <a16:creationId xmlns:a16="http://schemas.microsoft.com/office/drawing/2014/main" id="{60B9439A-FBB7-4F83-314E-1FC2D7EEB6E1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23114" y="696845"/>
            <a:ext cx="2533566" cy="2533566"/>
          </a:xfrm>
          <a:prstGeom prst="rect">
            <a:avLst/>
          </a:prstGeom>
        </p:spPr>
      </p:pic>
      <p:pic>
        <p:nvPicPr>
          <p:cNvPr id="8" name="Picture 58">
            <a:extLst>
              <a:ext uri="{FF2B5EF4-FFF2-40B4-BE49-F238E27FC236}">
                <a16:creationId xmlns:a16="http://schemas.microsoft.com/office/drawing/2014/main" id="{85A36625-2C08-B19E-63FC-E2E830BB27B8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3821" y="696845"/>
            <a:ext cx="2533566" cy="2533566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94081BF0-96C0-3407-9DDA-F0D7D583CCEE}"/>
              </a:ext>
            </a:extLst>
          </p:cNvPr>
          <p:cNvSpPr txBox="1"/>
          <p:nvPr/>
        </p:nvSpPr>
        <p:spPr>
          <a:xfrm>
            <a:off x="1545933" y="435949"/>
            <a:ext cx="12418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Fluorescence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0CC0F97E-030C-D196-752A-3A4FD2E75ED7}"/>
              </a:ext>
            </a:extLst>
          </p:cNvPr>
          <p:cNvSpPr txBox="1"/>
          <p:nvPr/>
        </p:nvSpPr>
        <p:spPr>
          <a:xfrm>
            <a:off x="4799161" y="435949"/>
            <a:ext cx="3882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BF</a:t>
            </a:r>
          </a:p>
        </p:txBody>
      </p:sp>
      <p:sp>
        <p:nvSpPr>
          <p:cNvPr id="28" name="ZoneTexte 17">
            <a:extLst>
              <a:ext uri="{FF2B5EF4-FFF2-40B4-BE49-F238E27FC236}">
                <a16:creationId xmlns:a16="http://schemas.microsoft.com/office/drawing/2014/main" id="{B2166478-08C7-0CB9-5A75-627ABB12789A}"/>
              </a:ext>
            </a:extLst>
          </p:cNvPr>
          <p:cNvSpPr txBox="1"/>
          <p:nvPr/>
        </p:nvSpPr>
        <p:spPr>
          <a:xfrm>
            <a:off x="1047453" y="725888"/>
            <a:ext cx="320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solidFill>
                  <a:schemeClr val="bg1"/>
                </a:solidFill>
              </a:rPr>
              <a:t>A</a:t>
            </a:r>
          </a:p>
        </p:txBody>
      </p:sp>
      <p:sp>
        <p:nvSpPr>
          <p:cNvPr id="29" name="ZoneTexte 18">
            <a:extLst>
              <a:ext uri="{FF2B5EF4-FFF2-40B4-BE49-F238E27FC236}">
                <a16:creationId xmlns:a16="http://schemas.microsoft.com/office/drawing/2014/main" id="{098FC30F-D9FA-C174-DC50-EB69C86773B8}"/>
              </a:ext>
            </a:extLst>
          </p:cNvPr>
          <p:cNvSpPr txBox="1"/>
          <p:nvPr/>
        </p:nvSpPr>
        <p:spPr>
          <a:xfrm>
            <a:off x="3630490" y="711943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solidFill>
                  <a:schemeClr val="bg1"/>
                </a:solidFill>
              </a:rPr>
              <a:t>B</a:t>
            </a:r>
          </a:p>
        </p:txBody>
      </p:sp>
      <p:sp>
        <p:nvSpPr>
          <p:cNvPr id="32" name="ZoneTexte 21">
            <a:extLst>
              <a:ext uri="{FF2B5EF4-FFF2-40B4-BE49-F238E27FC236}">
                <a16:creationId xmlns:a16="http://schemas.microsoft.com/office/drawing/2014/main" id="{FB413EF6-B7F4-488A-D403-959A28064B04}"/>
              </a:ext>
            </a:extLst>
          </p:cNvPr>
          <p:cNvSpPr txBox="1"/>
          <p:nvPr/>
        </p:nvSpPr>
        <p:spPr>
          <a:xfrm>
            <a:off x="6338388" y="71572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solidFill>
                  <a:schemeClr val="bg1"/>
                </a:solidFill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38332205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id="{B5824BC5-F27F-4AAC-9125-283F539BBD18}"/>
              </a:ext>
            </a:extLst>
          </p:cNvPr>
          <p:cNvSpPr txBox="1"/>
          <p:nvPr/>
        </p:nvSpPr>
        <p:spPr>
          <a:xfrm>
            <a:off x="2491220" y="2575240"/>
            <a:ext cx="4360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/>
              <a:t>75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2E9B6A1B-9F40-4F1E-9AB2-7249FDE91DFE}"/>
              </a:ext>
            </a:extLst>
          </p:cNvPr>
          <p:cNvSpPr txBox="1"/>
          <p:nvPr/>
        </p:nvSpPr>
        <p:spPr>
          <a:xfrm>
            <a:off x="2482346" y="2717052"/>
            <a:ext cx="4360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/>
              <a:t>60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ACB6239E-FAB4-4624-A856-7F38B1E3A08F}"/>
              </a:ext>
            </a:extLst>
          </p:cNvPr>
          <p:cNvSpPr txBox="1"/>
          <p:nvPr/>
        </p:nvSpPr>
        <p:spPr>
          <a:xfrm>
            <a:off x="2482346" y="2931965"/>
            <a:ext cx="4360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/>
              <a:t>45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92064662-D950-42A7-9F52-D2811AE92568}"/>
              </a:ext>
            </a:extLst>
          </p:cNvPr>
          <p:cNvSpPr txBox="1"/>
          <p:nvPr/>
        </p:nvSpPr>
        <p:spPr>
          <a:xfrm>
            <a:off x="2491220" y="3230824"/>
            <a:ext cx="4360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/>
              <a:t>35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70D8A7ED-892B-4616-8309-3C73715B847A}"/>
              </a:ext>
            </a:extLst>
          </p:cNvPr>
          <p:cNvSpPr txBox="1"/>
          <p:nvPr/>
        </p:nvSpPr>
        <p:spPr>
          <a:xfrm>
            <a:off x="2472864" y="3621992"/>
            <a:ext cx="3623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/>
              <a:t>25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9269B651-7A2C-4C55-9124-0E4F1D6D9A47}"/>
              </a:ext>
            </a:extLst>
          </p:cNvPr>
          <p:cNvSpPr txBox="1"/>
          <p:nvPr/>
        </p:nvSpPr>
        <p:spPr>
          <a:xfrm rot="16200000">
            <a:off x="2833381" y="1288902"/>
            <a:ext cx="12383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TdPP1 WT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406954BD-7662-4207-A2C0-C155EC14AF2F}"/>
              </a:ext>
            </a:extLst>
          </p:cNvPr>
          <p:cNvSpPr txBox="1"/>
          <p:nvPr/>
        </p:nvSpPr>
        <p:spPr>
          <a:xfrm rot="16200000">
            <a:off x="3061267" y="1110936"/>
            <a:ext cx="16231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TdPP1 T243M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83C0C5F6-DA5A-492E-B98E-FE0CD279C8C9}"/>
              </a:ext>
            </a:extLst>
          </p:cNvPr>
          <p:cNvSpPr txBox="1"/>
          <p:nvPr/>
        </p:nvSpPr>
        <p:spPr>
          <a:xfrm rot="16200000">
            <a:off x="3494338" y="1110936"/>
            <a:ext cx="16231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TdPP1 H135A</a:t>
            </a:r>
          </a:p>
        </p:txBody>
      </p:sp>
      <p:pic>
        <p:nvPicPr>
          <p:cNvPr id="13" name="Picture 2" descr="Aucune description disponible.">
            <a:extLst>
              <a:ext uri="{FF2B5EF4-FFF2-40B4-BE49-F238E27FC236}">
                <a16:creationId xmlns:a16="http://schemas.microsoft.com/office/drawing/2014/main" id="{C8BE8ECD-A9E7-44EC-A087-B4E24A341CF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28" t="39440" r="78578" b="47695"/>
          <a:stretch/>
        </p:blipFill>
        <p:spPr bwMode="auto">
          <a:xfrm>
            <a:off x="5097049" y="2045545"/>
            <a:ext cx="1784891" cy="22367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ZoneTexte 13">
            <a:extLst>
              <a:ext uri="{FF2B5EF4-FFF2-40B4-BE49-F238E27FC236}">
                <a16:creationId xmlns:a16="http://schemas.microsoft.com/office/drawing/2014/main" id="{56BA26FE-BCFD-439F-B8BD-333FD004241D}"/>
              </a:ext>
            </a:extLst>
          </p:cNvPr>
          <p:cNvSpPr txBox="1"/>
          <p:nvPr/>
        </p:nvSpPr>
        <p:spPr>
          <a:xfrm>
            <a:off x="4824579" y="2309833"/>
            <a:ext cx="4360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TN"/>
            </a:defPPr>
            <a:lvl1pPr>
              <a:defRPr sz="1100"/>
            </a:lvl1pPr>
          </a:lstStyle>
          <a:p>
            <a:r>
              <a:rPr lang="fr-FR" dirty="0"/>
              <a:t>75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B88D4336-9AE9-4795-90E7-02CF2439E84C}"/>
              </a:ext>
            </a:extLst>
          </p:cNvPr>
          <p:cNvSpPr txBox="1"/>
          <p:nvPr/>
        </p:nvSpPr>
        <p:spPr>
          <a:xfrm>
            <a:off x="4818225" y="2660679"/>
            <a:ext cx="4360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TN"/>
            </a:defPPr>
            <a:lvl1pPr>
              <a:defRPr sz="1100"/>
            </a:lvl1pPr>
          </a:lstStyle>
          <a:p>
            <a:r>
              <a:rPr lang="fr-FR" dirty="0"/>
              <a:t>60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5E7D6F96-C0FD-491E-99D5-93BC10B85008}"/>
              </a:ext>
            </a:extLst>
          </p:cNvPr>
          <p:cNvSpPr txBox="1"/>
          <p:nvPr/>
        </p:nvSpPr>
        <p:spPr>
          <a:xfrm>
            <a:off x="4818225" y="2985029"/>
            <a:ext cx="4360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TN"/>
            </a:defPPr>
            <a:lvl1pPr>
              <a:defRPr sz="1100"/>
            </a:lvl1pPr>
          </a:lstStyle>
          <a:p>
            <a:r>
              <a:rPr lang="fr-FR" dirty="0"/>
              <a:t>45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3A8C78AC-8004-4F7C-B135-8B11944B991E}"/>
              </a:ext>
            </a:extLst>
          </p:cNvPr>
          <p:cNvSpPr txBox="1"/>
          <p:nvPr/>
        </p:nvSpPr>
        <p:spPr>
          <a:xfrm>
            <a:off x="4818225" y="3432391"/>
            <a:ext cx="4360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/>
              <a:t>35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92BEDAF9-3265-4FA3-A17F-EB18098D5F78}"/>
              </a:ext>
            </a:extLst>
          </p:cNvPr>
          <p:cNvSpPr txBox="1"/>
          <p:nvPr/>
        </p:nvSpPr>
        <p:spPr>
          <a:xfrm>
            <a:off x="4818225" y="3935711"/>
            <a:ext cx="4360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TN"/>
            </a:defPPr>
            <a:lvl1pPr>
              <a:defRPr sz="1100"/>
            </a:lvl1pPr>
          </a:lstStyle>
          <a:p>
            <a:r>
              <a:rPr lang="fr-FR" dirty="0"/>
              <a:t>25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DBCB31A2-DD73-4F64-9AD4-17595674EE25}"/>
              </a:ext>
            </a:extLst>
          </p:cNvPr>
          <p:cNvSpPr txBox="1"/>
          <p:nvPr/>
        </p:nvSpPr>
        <p:spPr>
          <a:xfrm>
            <a:off x="5883038" y="1693760"/>
            <a:ext cx="9815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TdRL1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D6A727B8-2E7D-437D-B454-9D59A20D4307}"/>
              </a:ext>
            </a:extLst>
          </p:cNvPr>
          <p:cNvSpPr txBox="1"/>
          <p:nvPr/>
        </p:nvSpPr>
        <p:spPr>
          <a:xfrm>
            <a:off x="7154410" y="1681905"/>
            <a:ext cx="9077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At-I2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6C6CB84C-5681-4FAF-96D8-93835CD9B9E3}"/>
              </a:ext>
            </a:extLst>
          </p:cNvPr>
          <p:cNvSpPr txBox="1"/>
          <p:nvPr/>
        </p:nvSpPr>
        <p:spPr>
          <a:xfrm>
            <a:off x="2119270" y="1396710"/>
            <a:ext cx="4349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A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0E6F6005-8563-462E-B9D1-FEE9DBAEEB9C}"/>
              </a:ext>
            </a:extLst>
          </p:cNvPr>
          <p:cNvSpPr txBox="1"/>
          <p:nvPr/>
        </p:nvSpPr>
        <p:spPr>
          <a:xfrm>
            <a:off x="4886600" y="1396710"/>
            <a:ext cx="4349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B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761E571A-E7F6-4CCC-9183-D85EE86C7FAC}"/>
              </a:ext>
            </a:extLst>
          </p:cNvPr>
          <p:cNvSpPr txBox="1"/>
          <p:nvPr/>
        </p:nvSpPr>
        <p:spPr>
          <a:xfrm>
            <a:off x="6958373" y="1396710"/>
            <a:ext cx="4349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C</a:t>
            </a:r>
          </a:p>
        </p:txBody>
      </p:sp>
      <p:pic>
        <p:nvPicPr>
          <p:cNvPr id="24" name="Image 23">
            <a:extLst>
              <a:ext uri="{FF2B5EF4-FFF2-40B4-BE49-F238E27FC236}">
                <a16:creationId xmlns:a16="http://schemas.microsoft.com/office/drawing/2014/main" id="{CA23AA5B-A34E-437A-8175-F9019C5A94E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colorTemperature colorTemp="4700"/>
                    </a14:imgEffect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3550" t="47179" r="1134" b="28616"/>
          <a:stretch/>
        </p:blipFill>
        <p:spPr>
          <a:xfrm>
            <a:off x="7175837" y="1997120"/>
            <a:ext cx="1084496" cy="2285188"/>
          </a:xfrm>
          <a:prstGeom prst="rect">
            <a:avLst/>
          </a:prstGeom>
        </p:spPr>
      </p:pic>
      <p:grpSp>
        <p:nvGrpSpPr>
          <p:cNvPr id="2" name="Groupe 1">
            <a:extLst>
              <a:ext uri="{FF2B5EF4-FFF2-40B4-BE49-F238E27FC236}">
                <a16:creationId xmlns:a16="http://schemas.microsoft.com/office/drawing/2014/main" id="{2A489DD7-4A9D-AC33-F380-E07CDDD6D8E2}"/>
              </a:ext>
            </a:extLst>
          </p:cNvPr>
          <p:cNvGrpSpPr/>
          <p:nvPr/>
        </p:nvGrpSpPr>
        <p:grpSpPr>
          <a:xfrm>
            <a:off x="8173936" y="2120549"/>
            <a:ext cx="456269" cy="2097908"/>
            <a:chOff x="8173936" y="2120549"/>
            <a:chExt cx="456269" cy="2097908"/>
          </a:xfrm>
        </p:grpSpPr>
        <p:sp>
          <p:nvSpPr>
            <p:cNvPr id="25" name="ZoneTexte 24">
              <a:extLst>
                <a:ext uri="{FF2B5EF4-FFF2-40B4-BE49-F238E27FC236}">
                  <a16:creationId xmlns:a16="http://schemas.microsoft.com/office/drawing/2014/main" id="{911956A7-B0CB-4678-A0FD-0E0EED78772C}"/>
                </a:ext>
              </a:extLst>
            </p:cNvPr>
            <p:cNvSpPr txBox="1"/>
            <p:nvPr/>
          </p:nvSpPr>
          <p:spPr>
            <a:xfrm>
              <a:off x="8173936" y="2120549"/>
              <a:ext cx="43609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fr-TN"/>
              </a:defPPr>
              <a:lvl1pPr>
                <a:defRPr sz="1100"/>
              </a:lvl1pPr>
            </a:lstStyle>
            <a:p>
              <a:r>
                <a:rPr lang="fr-FR" dirty="0"/>
                <a:t>75</a:t>
              </a:r>
            </a:p>
          </p:txBody>
        </p:sp>
        <p:sp>
          <p:nvSpPr>
            <p:cNvPr id="26" name="ZoneTexte 25">
              <a:extLst>
                <a:ext uri="{FF2B5EF4-FFF2-40B4-BE49-F238E27FC236}">
                  <a16:creationId xmlns:a16="http://schemas.microsoft.com/office/drawing/2014/main" id="{46258940-3A3C-4E29-8BDA-245DAB7E9863}"/>
                </a:ext>
              </a:extLst>
            </p:cNvPr>
            <p:cNvSpPr txBox="1"/>
            <p:nvPr/>
          </p:nvSpPr>
          <p:spPr>
            <a:xfrm>
              <a:off x="8184685" y="2399069"/>
              <a:ext cx="43609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fr-TN"/>
              </a:defPPr>
              <a:lvl1pPr>
                <a:defRPr sz="1100"/>
              </a:lvl1pPr>
            </a:lstStyle>
            <a:p>
              <a:r>
                <a:rPr lang="fr-FR" dirty="0"/>
                <a:t>60</a:t>
              </a:r>
            </a:p>
          </p:txBody>
        </p:sp>
        <p:sp>
          <p:nvSpPr>
            <p:cNvPr id="27" name="ZoneTexte 26">
              <a:extLst>
                <a:ext uri="{FF2B5EF4-FFF2-40B4-BE49-F238E27FC236}">
                  <a16:creationId xmlns:a16="http://schemas.microsoft.com/office/drawing/2014/main" id="{B57AF014-F834-4E90-8EA8-F46E55B5D6F4}"/>
                </a:ext>
              </a:extLst>
            </p:cNvPr>
            <p:cNvSpPr txBox="1"/>
            <p:nvPr/>
          </p:nvSpPr>
          <p:spPr>
            <a:xfrm>
              <a:off x="8194107" y="3288139"/>
              <a:ext cx="43609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fr-TN"/>
              </a:defPPr>
              <a:lvl1pPr>
                <a:defRPr sz="1100"/>
              </a:lvl1pPr>
            </a:lstStyle>
            <a:p>
              <a:r>
                <a:rPr lang="fr-FR" dirty="0"/>
                <a:t>35</a:t>
              </a:r>
            </a:p>
          </p:txBody>
        </p:sp>
        <p:sp>
          <p:nvSpPr>
            <p:cNvPr id="28" name="ZoneTexte 27">
              <a:extLst>
                <a:ext uri="{FF2B5EF4-FFF2-40B4-BE49-F238E27FC236}">
                  <a16:creationId xmlns:a16="http://schemas.microsoft.com/office/drawing/2014/main" id="{2FDC344E-1032-4B58-A937-B58C03930510}"/>
                </a:ext>
              </a:extLst>
            </p:cNvPr>
            <p:cNvSpPr txBox="1"/>
            <p:nvPr/>
          </p:nvSpPr>
          <p:spPr>
            <a:xfrm>
              <a:off x="8195132" y="3849125"/>
              <a:ext cx="41520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fr-TN"/>
              </a:defPPr>
              <a:lvl1pPr>
                <a:defRPr sz="1100"/>
              </a:lvl1pPr>
            </a:lstStyle>
            <a:p>
              <a:r>
                <a:rPr lang="fr-FR" dirty="0"/>
                <a:t>25</a:t>
              </a:r>
            </a:p>
          </p:txBody>
        </p:sp>
        <p:sp>
          <p:nvSpPr>
            <p:cNvPr id="29" name="ZoneTexte 28">
              <a:extLst>
                <a:ext uri="{FF2B5EF4-FFF2-40B4-BE49-F238E27FC236}">
                  <a16:creationId xmlns:a16="http://schemas.microsoft.com/office/drawing/2014/main" id="{85004C70-9D51-42E5-AE1F-0BAD42EF1BDB}"/>
                </a:ext>
              </a:extLst>
            </p:cNvPr>
            <p:cNvSpPr txBox="1"/>
            <p:nvPr/>
          </p:nvSpPr>
          <p:spPr>
            <a:xfrm>
              <a:off x="8194107" y="2772113"/>
              <a:ext cx="43609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/>
                <a:t>45</a:t>
              </a:r>
            </a:p>
          </p:txBody>
        </p:sp>
      </p:grpSp>
      <p:sp>
        <p:nvSpPr>
          <p:cNvPr id="30" name="ZoneTexte 29">
            <a:extLst>
              <a:ext uri="{FF2B5EF4-FFF2-40B4-BE49-F238E27FC236}">
                <a16:creationId xmlns:a16="http://schemas.microsoft.com/office/drawing/2014/main" id="{76EEE46D-6999-46E6-A603-F11ED7F68B75}"/>
              </a:ext>
            </a:extLst>
          </p:cNvPr>
          <p:cNvSpPr txBox="1"/>
          <p:nvPr/>
        </p:nvSpPr>
        <p:spPr>
          <a:xfrm>
            <a:off x="2293216" y="2199437"/>
            <a:ext cx="6199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/>
              <a:t>kDa</a:t>
            </a: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06602378-9EF7-4F08-B33C-00146388255D}"/>
              </a:ext>
            </a:extLst>
          </p:cNvPr>
          <p:cNvSpPr txBox="1"/>
          <p:nvPr/>
        </p:nvSpPr>
        <p:spPr>
          <a:xfrm>
            <a:off x="765545" y="4839753"/>
            <a:ext cx="9994603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fr-FR" dirty="0" err="1">
                <a:latin typeface="Arial" panose="020B0604020202020204" pitchFamily="34" charset="0"/>
                <a:ea typeface="Calibri" panose="020F0502020204030204" pitchFamily="34" charset="0"/>
              </a:rPr>
              <a:t>Supplementary</a:t>
            </a:r>
            <a:r>
              <a:rPr lang="fr-FR" dirty="0">
                <a:latin typeface="Arial" panose="020B0604020202020204" pitchFamily="34" charset="0"/>
                <a:ea typeface="Calibri" panose="020F0502020204030204" pitchFamily="34" charset="0"/>
              </a:rPr>
              <a:t> F</a:t>
            </a:r>
            <a:r>
              <a:rPr lang="fr-FR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igure S2</a:t>
            </a:r>
            <a:r>
              <a:rPr lang="fr-FR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: </a:t>
            </a:r>
            <a:r>
              <a:rPr lang="en-US" b="0" i="0" dirty="0">
                <a:solidFill>
                  <a:schemeClr val="tx1">
                    <a:lumMod val="95000"/>
                    <a:lumOff val="5000"/>
                  </a:schemeClr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2% SDS-PAGE gel stained with Coomassie brilliant with the different recombinant proteins after purification: </a:t>
            </a:r>
            <a:r>
              <a:rPr lang="fr-FR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b="0" i="0" dirty="0">
                <a:solidFill>
                  <a:schemeClr val="tx1">
                    <a:lumMod val="95000"/>
                    <a:lumOff val="5000"/>
                  </a:schemeClr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6x</a:t>
            </a:r>
            <a:r>
              <a:rPr lang="fr-FR" sz="1800" dirty="0" err="1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s</a:t>
            </a:r>
            <a:r>
              <a:rPr lang="fr-FR" sz="1800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::</a:t>
            </a:r>
            <a:r>
              <a:rPr lang="fr-FR" sz="1800" i="1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Td</a:t>
            </a:r>
            <a:r>
              <a:rPr lang="fr-FR" sz="1800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P1, </a:t>
            </a:r>
            <a:r>
              <a:rPr lang="en-US" b="0" i="0" dirty="0">
                <a:solidFill>
                  <a:schemeClr val="tx1">
                    <a:lumMod val="95000"/>
                    <a:lumOff val="5000"/>
                  </a:schemeClr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6x</a:t>
            </a:r>
            <a:r>
              <a:rPr lang="fr-FR" sz="1800" dirty="0" err="1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s</a:t>
            </a:r>
            <a:r>
              <a:rPr lang="fr-FR" sz="1800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::</a:t>
            </a:r>
            <a:r>
              <a:rPr lang="fr-FR" sz="1800" i="1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Td</a:t>
            </a:r>
            <a:r>
              <a:rPr lang="fr-FR" sz="1800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P1-</a:t>
            </a:r>
            <a:r>
              <a:rPr lang="fr-FR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fr-FR" sz="1800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43M, </a:t>
            </a:r>
            <a:r>
              <a:rPr lang="en-US" b="0" i="0" dirty="0">
                <a:solidFill>
                  <a:schemeClr val="tx1">
                    <a:lumMod val="95000"/>
                    <a:lumOff val="5000"/>
                  </a:schemeClr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6x</a:t>
            </a:r>
            <a:r>
              <a:rPr lang="fr-FR" sz="1800" dirty="0" err="1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s</a:t>
            </a:r>
            <a:r>
              <a:rPr lang="fr-FR" sz="1800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::</a:t>
            </a:r>
            <a:r>
              <a:rPr lang="fr-FR" sz="1800" i="1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Td</a:t>
            </a:r>
            <a:r>
              <a:rPr lang="fr-FR" sz="1800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P1-H135A</a:t>
            </a:r>
            <a:r>
              <a:rPr lang="en-US" b="0" i="0" dirty="0">
                <a:solidFill>
                  <a:schemeClr val="tx1">
                    <a:lumMod val="95000"/>
                    <a:lumOff val="5000"/>
                  </a:schemeClr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6x</a:t>
            </a:r>
            <a:r>
              <a:rPr lang="fr-FR" sz="1800" dirty="0" err="1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s</a:t>
            </a:r>
            <a:r>
              <a:rPr lang="fr-FR" sz="1800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-MBP::</a:t>
            </a:r>
            <a:r>
              <a:rPr lang="fr-FR" sz="1800" i="1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Td</a:t>
            </a:r>
            <a:r>
              <a:rPr lang="fr-FR" sz="1800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L1 (B) and GST::</a:t>
            </a:r>
            <a:r>
              <a:rPr lang="fr-FR" sz="1800" i="1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</a:t>
            </a:r>
            <a:r>
              <a:rPr lang="fr-FR" sz="1800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-I2 (C)</a:t>
            </a:r>
            <a:r>
              <a:rPr lang="en-US" b="0" i="0" dirty="0">
                <a:solidFill>
                  <a:schemeClr val="tx1">
                    <a:lumMod val="95000"/>
                    <a:lumOff val="5000"/>
                  </a:schemeClr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 The proteins were purified using nickel affinity columns for His-tagged proteins and a glutathione affinity columns for GST-tagged proteins. </a:t>
            </a:r>
            <a:r>
              <a:rPr lang="en-US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lecular weight are indicated in </a:t>
            </a:r>
            <a:r>
              <a:rPr lang="en-US" dirty="0" err="1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fr-FR" dirty="0"/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FDED2300-DC89-4464-AFBD-2BEF2E1B51CE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2319" r="3414" b="32951"/>
          <a:stretch/>
        </p:blipFill>
        <p:spPr>
          <a:xfrm>
            <a:off x="2750145" y="2074947"/>
            <a:ext cx="1990491" cy="2167804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9E4E2F83-0DF4-E1D9-3A32-0B4C7CE5F4FF}"/>
              </a:ext>
            </a:extLst>
          </p:cNvPr>
          <p:cNvSpPr txBox="1"/>
          <p:nvPr/>
        </p:nvSpPr>
        <p:spPr>
          <a:xfrm>
            <a:off x="11098624" y="6488668"/>
            <a:ext cx="1093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3502976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B2193284-4B43-48F8-B148-4862F7365BA7}"/>
              </a:ext>
            </a:extLst>
          </p:cNvPr>
          <p:cNvSpPr txBox="1"/>
          <p:nvPr/>
        </p:nvSpPr>
        <p:spPr>
          <a:xfrm>
            <a:off x="10946364" y="6488668"/>
            <a:ext cx="284278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  <a:r>
              <a:rPr lang="fr-FR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gure S3</a:t>
            </a: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8CD21C35-A258-45EB-AB7F-41E6194BE0B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0" y="178300"/>
            <a:ext cx="6939507" cy="6789626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40B423F0-79FE-4EDD-950D-F0D8141EF471}"/>
              </a:ext>
            </a:extLst>
          </p:cNvPr>
          <p:cNvSpPr/>
          <p:nvPr/>
        </p:nvSpPr>
        <p:spPr>
          <a:xfrm>
            <a:off x="3102964" y="2419843"/>
            <a:ext cx="104931" cy="106055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6A11FBF1-785E-48B6-BCDF-FAA15797E44E}"/>
              </a:ext>
            </a:extLst>
          </p:cNvPr>
          <p:cNvSpPr/>
          <p:nvPr/>
        </p:nvSpPr>
        <p:spPr>
          <a:xfrm>
            <a:off x="2475578" y="5149121"/>
            <a:ext cx="117423" cy="22485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F356D972-87B4-493C-963F-86555219BC4D}"/>
              </a:ext>
            </a:extLst>
          </p:cNvPr>
          <p:cNvSpPr/>
          <p:nvPr/>
        </p:nvSpPr>
        <p:spPr>
          <a:xfrm>
            <a:off x="2185693" y="5373974"/>
            <a:ext cx="117422" cy="22485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D1B1651A-6061-5A63-6599-E541C108207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068934" y="178300"/>
            <a:ext cx="5048236" cy="2352249"/>
          </a:xfrm>
          <a:prstGeom prst="rect">
            <a:avLst/>
          </a:prstGeom>
        </p:spPr>
      </p:pic>
      <p:pic>
        <p:nvPicPr>
          <p:cNvPr id="8" name="Image 7">
            <a:extLst>
              <a:ext uri="{FF2B5EF4-FFF2-40B4-BE49-F238E27FC236}">
                <a16:creationId xmlns:a16="http://schemas.microsoft.com/office/drawing/2014/main" id="{D6CFA190-1DE1-626F-6B10-3C542ACE9DA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147823" y="3087896"/>
            <a:ext cx="4926431" cy="2286078"/>
          </a:xfrm>
          <a:prstGeom prst="rect">
            <a:avLst/>
          </a:prstGeom>
          <a:ln>
            <a:noFill/>
          </a:ln>
        </p:spPr>
      </p:pic>
      <p:sp>
        <p:nvSpPr>
          <p:cNvPr id="10" name="ZoneTexte 9">
            <a:extLst>
              <a:ext uri="{FF2B5EF4-FFF2-40B4-BE49-F238E27FC236}">
                <a16:creationId xmlns:a16="http://schemas.microsoft.com/office/drawing/2014/main" id="{6804C6EC-0AF9-2200-3D16-4BBCF26B897B}"/>
              </a:ext>
            </a:extLst>
          </p:cNvPr>
          <p:cNvSpPr txBox="1"/>
          <p:nvPr/>
        </p:nvSpPr>
        <p:spPr>
          <a:xfrm>
            <a:off x="-5746" y="-97253"/>
            <a:ext cx="4349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A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987AC039-5C0A-51ED-F177-4646C9FF232E}"/>
              </a:ext>
            </a:extLst>
          </p:cNvPr>
          <p:cNvSpPr txBox="1"/>
          <p:nvPr/>
        </p:nvSpPr>
        <p:spPr>
          <a:xfrm>
            <a:off x="6785968" y="24517"/>
            <a:ext cx="4349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B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80FBA878-9842-CFF3-651F-E7BCF49D1C4B}"/>
              </a:ext>
            </a:extLst>
          </p:cNvPr>
          <p:cNvSpPr txBox="1"/>
          <p:nvPr/>
        </p:nvSpPr>
        <p:spPr>
          <a:xfrm>
            <a:off x="6851470" y="2765454"/>
            <a:ext cx="4349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5739423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ZoneTexte 8">
            <a:extLst>
              <a:ext uri="{FF2B5EF4-FFF2-40B4-BE49-F238E27FC236}">
                <a16:creationId xmlns:a16="http://schemas.microsoft.com/office/drawing/2014/main" id="{D11FEA7A-145B-43C6-BE06-AA35EA8830C3}"/>
              </a:ext>
            </a:extLst>
          </p:cNvPr>
          <p:cNvSpPr txBox="1"/>
          <p:nvPr/>
        </p:nvSpPr>
        <p:spPr>
          <a:xfrm>
            <a:off x="685800" y="960160"/>
            <a:ext cx="10515600" cy="31393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Figure S3:</a:t>
            </a:r>
          </a:p>
          <a:p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(A) Multiple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protein-sequence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alignment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of PP1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different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species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sequences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for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alignment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are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i="1" dirty="0">
                <a:latin typeface="Arial" panose="020B0604020202020204" pitchFamily="34" charset="0"/>
                <a:cs typeface="Arial" panose="020B0604020202020204" pitchFamily="34" charset="0"/>
              </a:rPr>
              <a:t>Mus </a:t>
            </a:r>
            <a:r>
              <a:rPr lang="fr-FR" i="1" dirty="0" err="1">
                <a:latin typeface="Arial" panose="020B0604020202020204" pitchFamily="34" charset="0"/>
                <a:cs typeface="Arial" panose="020B0604020202020204" pitchFamily="34" charset="0"/>
              </a:rPr>
              <a:t>musculus</a:t>
            </a:r>
            <a:r>
              <a:rPr lang="fr-FR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(NP_038664), </a:t>
            </a:r>
            <a:r>
              <a:rPr lang="fr-FR" i="1" dirty="0">
                <a:latin typeface="Arial" panose="020B0604020202020204" pitchFamily="34" charset="0"/>
                <a:cs typeface="Arial" panose="020B0604020202020204" pitchFamily="34" charset="0"/>
              </a:rPr>
              <a:t>Homo sapiens 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(NP_002701),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durum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wheat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r-FR" i="1" dirty="0" err="1">
                <a:latin typeface="Arial" panose="020B0604020202020204" pitchFamily="34" charset="0"/>
                <a:cs typeface="Arial" panose="020B0604020202020204" pitchFamily="34" charset="0"/>
              </a:rPr>
              <a:t>Triticum</a:t>
            </a:r>
            <a:r>
              <a:rPr lang="fr-FR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i="1" dirty="0" err="1">
                <a:latin typeface="Arial" panose="020B0604020202020204" pitchFamily="34" charset="0"/>
                <a:cs typeface="Arial" panose="020B0604020202020204" pitchFamily="34" charset="0"/>
              </a:rPr>
              <a:t>durum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, TRITD4Bv1G129020), and </a:t>
            </a:r>
            <a:r>
              <a:rPr lang="fr-FR" i="1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Arabidopsis thaliana</a:t>
            </a:r>
            <a:r>
              <a:rPr lang="fr-FR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(AT2G39840).</a:t>
            </a:r>
          </a:p>
          <a:p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Catalytic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residue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His135 and Thr243 in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durum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wheat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r-FR" i="1" dirty="0" err="1">
                <a:latin typeface="Arial" panose="020B0604020202020204" pitchFamily="34" charset="0"/>
                <a:cs typeface="Arial" panose="020B0604020202020204" pitchFamily="34" charset="0"/>
              </a:rPr>
              <a:t>Triticum</a:t>
            </a:r>
            <a:r>
              <a:rPr lang="fr-FR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i="1" dirty="0" err="1">
                <a:latin typeface="Arial" panose="020B0604020202020204" pitchFamily="34" charset="0"/>
                <a:cs typeface="Arial" panose="020B0604020202020204" pitchFamily="34" charset="0"/>
              </a:rPr>
              <a:t>durum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), and Thr247 in TOPP4 of Arabidopsis thaliana, are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highlighted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rectangular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boxes. The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alignment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performed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using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the CLUSTAL OMEGA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tool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  <a:p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(B) TdPP1 Thr243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putatively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phosphorylated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(C) TOPP4 Thr247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putatively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phosphorylated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Prediction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both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putative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phospho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-sites has been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performed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using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NetPhos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3.1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defaults settings. https://services.healthtech.dtu.dk/services/NetPhos-3.1</a:t>
            </a:r>
            <a:r>
              <a:rPr lang="fr-FR" dirty="0"/>
              <a:t>/</a:t>
            </a:r>
          </a:p>
          <a:p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3145684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 5">
            <a:extLst>
              <a:ext uri="{FF2B5EF4-FFF2-40B4-BE49-F238E27FC236}">
                <a16:creationId xmlns:a16="http://schemas.microsoft.com/office/drawing/2014/main" id="{C9C2EDFC-3AB2-D160-AB68-75F5FD5BA5A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0896" y="1012515"/>
            <a:ext cx="11247120" cy="1843459"/>
          </a:xfrm>
          <a:prstGeom prst="rect">
            <a:avLst/>
          </a:prstGeom>
        </p:spPr>
      </p:pic>
      <p:sp>
        <p:nvSpPr>
          <p:cNvPr id="8" name="ZoneTexte 7">
            <a:extLst>
              <a:ext uri="{FF2B5EF4-FFF2-40B4-BE49-F238E27FC236}">
                <a16:creationId xmlns:a16="http://schemas.microsoft.com/office/drawing/2014/main" id="{5E2C66FF-2E33-0FB3-23F2-FD9230C12F29}"/>
              </a:ext>
            </a:extLst>
          </p:cNvPr>
          <p:cNvSpPr txBox="1"/>
          <p:nvPr/>
        </p:nvSpPr>
        <p:spPr>
          <a:xfrm>
            <a:off x="2104262" y="3550980"/>
            <a:ext cx="8173593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Figure S4:</a:t>
            </a:r>
          </a:p>
          <a:p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Protein-sequence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alignment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i="1" dirty="0">
                <a:latin typeface="Arial" panose="020B0604020202020204" pitchFamily="34" charset="0"/>
                <a:cs typeface="Arial" panose="020B0604020202020204" pitchFamily="34" charset="0"/>
              </a:rPr>
              <a:t>Os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RSS1 and </a:t>
            </a:r>
            <a:r>
              <a:rPr lang="fr-FR" i="1" dirty="0">
                <a:latin typeface="Arial" panose="020B0604020202020204" pitchFamily="34" charset="0"/>
                <a:cs typeface="Arial" panose="020B0604020202020204" pitchFamily="34" charset="0"/>
              </a:rPr>
              <a:t>Td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RL1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performed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using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MEGA X software. Putative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RvXF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motifs are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highlighted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in orange. Basic and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acidic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stretches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are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highlighted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in green </a:t>
            </a:r>
            <a:r>
              <a:rPr lang="fr-FR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according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Mahjoubi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et al., 2015)</a:t>
            </a:r>
          </a:p>
        </p:txBody>
      </p:sp>
    </p:spTree>
    <p:extLst>
      <p:ext uri="{BB962C8B-B14F-4D97-AF65-F5344CB8AC3E}">
        <p14:creationId xmlns:p14="http://schemas.microsoft.com/office/powerpoint/2010/main" val="25264963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5A30A076-42D2-D72E-FF8A-00A31F511182}"/>
              </a:ext>
            </a:extLst>
          </p:cNvPr>
          <p:cNvSpPr txBox="1"/>
          <p:nvPr/>
        </p:nvSpPr>
        <p:spPr>
          <a:xfrm>
            <a:off x="2657077" y="2782669"/>
            <a:ext cx="687784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3600" dirty="0"/>
              <a:t>Original blots of </a:t>
            </a:r>
            <a:r>
              <a:rPr lang="fr-FR" sz="3600" dirty="0" err="1"/>
              <a:t>coIP</a:t>
            </a:r>
            <a:r>
              <a:rPr lang="fr-FR" sz="3600" dirty="0"/>
              <a:t> </a:t>
            </a:r>
            <a:r>
              <a:rPr lang="fr-FR" sz="3600" dirty="0" err="1"/>
              <a:t>experiments</a:t>
            </a:r>
            <a:endParaRPr lang="fr-FR" sz="3600" dirty="0"/>
          </a:p>
        </p:txBody>
      </p:sp>
    </p:spTree>
    <p:extLst>
      <p:ext uri="{BB962C8B-B14F-4D97-AF65-F5344CB8AC3E}">
        <p14:creationId xmlns:p14="http://schemas.microsoft.com/office/powerpoint/2010/main" val="28789711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/>
          <a:srcRect l="21757" r="43686" b="50000"/>
          <a:stretch>
            <a:fillRect/>
          </a:stretch>
        </p:blipFill>
        <p:spPr bwMode="auto">
          <a:xfrm>
            <a:off x="1858065" y="1531400"/>
            <a:ext cx="3857652" cy="27765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ZoneTexte 5"/>
          <p:cNvSpPr txBox="1"/>
          <p:nvPr/>
        </p:nvSpPr>
        <p:spPr>
          <a:xfrm>
            <a:off x="3921980" y="1703930"/>
            <a:ext cx="40719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Input </a:t>
            </a:r>
            <a:r>
              <a:rPr lang="fr-FR" dirty="0" err="1"/>
              <a:t>with</a:t>
            </a:r>
            <a:r>
              <a:rPr lang="fr-FR" dirty="0"/>
              <a:t> anti-GFP</a:t>
            </a:r>
          </a:p>
        </p:txBody>
      </p:sp>
      <p:sp>
        <p:nvSpPr>
          <p:cNvPr id="8" name="ZoneTexte 7"/>
          <p:cNvSpPr txBox="1"/>
          <p:nvPr/>
        </p:nvSpPr>
        <p:spPr>
          <a:xfrm>
            <a:off x="1881158" y="500042"/>
            <a:ext cx="3554948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Original blot  33.4 sec exposition </a:t>
            </a:r>
          </a:p>
          <a:p>
            <a:r>
              <a:rPr lang="fr-FR" dirty="0" err="1"/>
              <a:t>IP:CoIP</a:t>
            </a:r>
            <a:r>
              <a:rPr lang="fr-FR" dirty="0"/>
              <a:t> D1, C1, B1 and A1, ladder,</a:t>
            </a:r>
          </a:p>
          <a:p>
            <a:r>
              <a:rPr lang="fr-FR" dirty="0"/>
              <a:t>Input D1, C1, B1 and A1</a:t>
            </a:r>
          </a:p>
        </p:txBody>
      </p:sp>
      <p:sp>
        <p:nvSpPr>
          <p:cNvPr id="9" name="Rectangle 8"/>
          <p:cNvSpPr/>
          <p:nvPr/>
        </p:nvSpPr>
        <p:spPr>
          <a:xfrm>
            <a:off x="2443456" y="1724771"/>
            <a:ext cx="92204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/>
              <a:t>IP:CoIP</a:t>
            </a:r>
            <a:endParaRPr lang="fr-FR" dirty="0"/>
          </a:p>
        </p:txBody>
      </p:sp>
      <p:sp>
        <p:nvSpPr>
          <p:cNvPr id="11" name="ZoneTexte 10"/>
          <p:cNvSpPr txBox="1"/>
          <p:nvPr/>
        </p:nvSpPr>
        <p:spPr>
          <a:xfrm>
            <a:off x="5681373" y="2773352"/>
            <a:ext cx="10715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dirty="0"/>
              <a:t>α</a:t>
            </a:r>
            <a:r>
              <a:rPr lang="fr-FR" dirty="0"/>
              <a:t>- GFP</a:t>
            </a:r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3"/>
          <a:srcRect l="20478" t="4974" r="24488" b="16552"/>
          <a:stretch>
            <a:fillRect/>
          </a:stretch>
        </p:blipFill>
        <p:spPr bwMode="auto">
          <a:xfrm>
            <a:off x="2309786" y="4476480"/>
            <a:ext cx="3357586" cy="23815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D3041C20-F249-8D3B-D8AE-7221B4815C49}"/>
              </a:ext>
            </a:extLst>
          </p:cNvPr>
          <p:cNvSpPr/>
          <p:nvPr/>
        </p:nvSpPr>
        <p:spPr>
          <a:xfrm>
            <a:off x="1567180" y="4692598"/>
            <a:ext cx="6238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/>
              <a:t>CBB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3E3BF5D6-910B-D2FA-18B5-E8B7FE74275A}"/>
              </a:ext>
            </a:extLst>
          </p:cNvPr>
          <p:cNvSpPr txBox="1"/>
          <p:nvPr/>
        </p:nvSpPr>
        <p:spPr>
          <a:xfrm>
            <a:off x="4075178" y="4194715"/>
            <a:ext cx="461314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dirty="0"/>
              <a:t>D1  C1   B1   A1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1165D72C-5210-5D7C-3CB4-F2B67243A0FE}"/>
              </a:ext>
            </a:extLst>
          </p:cNvPr>
          <p:cNvSpPr txBox="1"/>
          <p:nvPr/>
        </p:nvSpPr>
        <p:spPr>
          <a:xfrm>
            <a:off x="2342003" y="3891574"/>
            <a:ext cx="461314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dirty="0" err="1"/>
              <a:t>IP:CoIP</a:t>
            </a:r>
            <a:r>
              <a:rPr lang="fr-FR" dirty="0"/>
              <a:t> </a:t>
            </a:r>
          </a:p>
          <a:p>
            <a:r>
              <a:rPr lang="fr-FR" dirty="0"/>
              <a:t>D1  C1  B1 A1 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2FDB9468-0FF7-B679-F2F8-70AFEA215B13}"/>
              </a:ext>
            </a:extLst>
          </p:cNvPr>
          <p:cNvSpPr txBox="1"/>
          <p:nvPr/>
        </p:nvSpPr>
        <p:spPr>
          <a:xfrm>
            <a:off x="4464657" y="3909837"/>
            <a:ext cx="457657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dirty="0"/>
              <a:t>Input</a:t>
            </a:r>
          </a:p>
        </p:txBody>
      </p:sp>
      <p:pic>
        <p:nvPicPr>
          <p:cNvPr id="16" name="Image 15">
            <a:extLst>
              <a:ext uri="{FF2B5EF4-FFF2-40B4-BE49-F238E27FC236}">
                <a16:creationId xmlns:a16="http://schemas.microsoft.com/office/drawing/2014/main" id="{D098D119-B962-7153-A4A6-0F2D23F1216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37709" y="296626"/>
            <a:ext cx="3420152" cy="1536325"/>
          </a:xfrm>
          <a:prstGeom prst="rect">
            <a:avLst/>
          </a:prstGeom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/>
          <a:srcRect l="22321" t="10526" r="18367" b="10526"/>
          <a:stretch>
            <a:fillRect/>
          </a:stretch>
        </p:blipFill>
        <p:spPr bwMode="auto">
          <a:xfrm>
            <a:off x="2666976" y="1928802"/>
            <a:ext cx="6643702" cy="41434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ZoneTexte 3"/>
          <p:cNvSpPr txBox="1"/>
          <p:nvPr/>
        </p:nvSpPr>
        <p:spPr>
          <a:xfrm>
            <a:off x="1855310" y="371283"/>
            <a:ext cx="34497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Original blot  33.4 sec exposition </a:t>
            </a:r>
          </a:p>
        </p:txBody>
      </p:sp>
      <p:pic>
        <p:nvPicPr>
          <p:cNvPr id="2" name="Picture 2">
            <a:extLst>
              <a:ext uri="{FF2B5EF4-FFF2-40B4-BE49-F238E27FC236}">
                <a16:creationId xmlns:a16="http://schemas.microsoft.com/office/drawing/2014/main" id="{4851765A-DF2E-3EBE-6F52-04DF7818A61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/>
          <a:srcRect l="22511" t="52734" r="39604" b="16992"/>
          <a:stretch>
            <a:fillRect/>
          </a:stretch>
        </p:blipFill>
        <p:spPr bwMode="auto">
          <a:xfrm>
            <a:off x="6744072" y="0"/>
            <a:ext cx="3417054" cy="15351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1DC0D8CA-C19C-E8B7-D392-6C14507D336C}"/>
              </a:ext>
            </a:extLst>
          </p:cNvPr>
          <p:cNvSpPr txBox="1"/>
          <p:nvPr/>
        </p:nvSpPr>
        <p:spPr>
          <a:xfrm>
            <a:off x="2711624" y="6132473"/>
            <a:ext cx="4572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                 D1,       C1      B1       A1   ladder  </a:t>
            </a:r>
          </a:p>
          <a:p>
            <a:r>
              <a:rPr lang="en-US" dirty="0" err="1"/>
              <a:t>IP:CoIP</a:t>
            </a:r>
            <a:r>
              <a:rPr lang="en-US" dirty="0"/>
              <a:t> 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89BB5B87-8BB7-C0A0-87B7-AD5DA434756E}"/>
              </a:ext>
            </a:extLst>
          </p:cNvPr>
          <p:cNvSpPr txBox="1"/>
          <p:nvPr/>
        </p:nvSpPr>
        <p:spPr>
          <a:xfrm>
            <a:off x="6528048" y="6063653"/>
            <a:ext cx="4572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dirty="0"/>
              <a:t>Input </a:t>
            </a:r>
          </a:p>
          <a:p>
            <a:r>
              <a:rPr lang="fr-FR" dirty="0"/>
              <a:t>D1       C1       B1        A1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81AF1357-EA82-EDD0-B66D-2DE091455900}"/>
              </a:ext>
            </a:extLst>
          </p:cNvPr>
          <p:cNvSpPr txBox="1"/>
          <p:nvPr/>
        </p:nvSpPr>
        <p:spPr>
          <a:xfrm>
            <a:off x="9525024" y="4000504"/>
            <a:ext cx="10715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dirty="0"/>
              <a:t>α</a:t>
            </a:r>
            <a:r>
              <a:rPr lang="fr-FR" dirty="0"/>
              <a:t>- HA</a:t>
            </a: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7506436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469</TotalTime>
  <Words>464</Words>
  <Application>Microsoft Office PowerPoint</Application>
  <PresentationFormat>Grand écran</PresentationFormat>
  <Paragraphs>74</Paragraphs>
  <Slides>9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9</vt:i4>
      </vt:variant>
    </vt:vector>
  </HeadingPairs>
  <TitlesOfParts>
    <vt:vector size="15" baseType="lpstr">
      <vt:lpstr>Aptos</vt:lpstr>
      <vt:lpstr>Aptos Display</vt:lpstr>
      <vt:lpstr>Arial</vt:lpstr>
      <vt:lpstr>Calibri</vt:lpstr>
      <vt:lpstr>Symbol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hantal Ebel</dc:creator>
  <cp:lastModifiedBy>Chantal Ebel</cp:lastModifiedBy>
  <cp:revision>310</cp:revision>
  <dcterms:created xsi:type="dcterms:W3CDTF">2024-04-06T08:55:56Z</dcterms:created>
  <dcterms:modified xsi:type="dcterms:W3CDTF">2025-03-05T14:57:20Z</dcterms:modified>
</cp:coreProperties>
</file>